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4" r:id="rId2"/>
    <p:sldId id="329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5"/>
    <p:restoredTop sz="96197"/>
  </p:normalViewPr>
  <p:slideViewPr>
    <p:cSldViewPr snapToGrid="0">
      <p:cViewPr varScale="1">
        <p:scale>
          <a:sx n="106" d="100"/>
          <a:sy n="106" d="100"/>
        </p:scale>
        <p:origin x="216" y="5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1513FCB-C51C-7F8C-2BB6-CD6C6C0942F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AEA39503-1210-B6CE-2DC5-56F3062E6AA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00E87CA-FC91-201F-36A8-337757B103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79B21-1E7E-E942-8EE5-E28162366F82}" type="datetimeFigureOut">
              <a:rPr kumimoji="1" lang="ja-JP" altLang="en-US" smtClean="0"/>
              <a:t>2023/8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B513CCB-EE0D-AE8E-C893-BFF97E2457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625A7BF-44F4-C406-6B5F-F328529B3D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C8AF9D-C38D-7B46-AAEB-D270530722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86353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B9C8422-9589-A077-CDE8-07C750B288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9AE6F27-C73F-5122-F1EE-960D2923A7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DAECC33-EC55-B0CB-8516-95B80F2F13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79B21-1E7E-E942-8EE5-E28162366F82}" type="datetimeFigureOut">
              <a:rPr kumimoji="1" lang="ja-JP" altLang="en-US" smtClean="0"/>
              <a:t>2023/8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BA279B5-5505-45CF-55F2-6DA15A749E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6169163-F8D5-9695-CF9D-56B9915F20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C8AF9D-C38D-7B46-AAEB-D270530722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41851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211F4954-BD5A-481B-21BE-344D4B3E44E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E95B8EE9-3BEF-C7FD-4882-5E1681C32E0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00D9ACC-7CE4-DB78-BEFC-09D3C95777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79B21-1E7E-E942-8EE5-E28162366F82}" type="datetimeFigureOut">
              <a:rPr kumimoji="1" lang="ja-JP" altLang="en-US" smtClean="0"/>
              <a:t>2023/8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F46E37E-18E4-1DA4-5B91-051A4DA67B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10325CB-C62E-7EDF-E719-983AD56EAE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C8AF9D-C38D-7B46-AAEB-D270530722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475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CC9AA0B-BEC0-E03D-4099-8AF76665D5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298BA3C-BD0B-5ED1-7556-68D64649C5D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956CA36-1E51-4F91-6D9A-A132F9ED2B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79B21-1E7E-E942-8EE5-E28162366F82}" type="datetimeFigureOut">
              <a:rPr kumimoji="1" lang="ja-JP" altLang="en-US" smtClean="0"/>
              <a:t>2023/8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6576F11-7DEA-8478-F612-52159A8B4E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644DCC1-BD0C-2739-85B7-DD4DCCE71C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C8AF9D-C38D-7B46-AAEB-D270530722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84328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45EC668-33F9-B371-CBBF-6DB78BFF17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3C742F6-7F88-31DE-6412-56F8383EEDA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D6A43DE-FF8E-620A-C94B-75CA0DC4C8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79B21-1E7E-E942-8EE5-E28162366F82}" type="datetimeFigureOut">
              <a:rPr kumimoji="1" lang="ja-JP" altLang="en-US" smtClean="0"/>
              <a:t>2023/8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5D8D21F-2939-9449-AD90-08368A0AD8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89F16CC-FEF6-5A7D-8655-078E1BDBD4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C8AF9D-C38D-7B46-AAEB-D270530722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04874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1CA74B7-0C54-C7DF-4F83-10DD7AF049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0490CD1-6EB0-DEAB-B3B6-3F9C1B43614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D641CA30-C362-F39F-2D6F-672125C0675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1379113-C169-6D24-69C3-965225BBD5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79B21-1E7E-E942-8EE5-E28162366F82}" type="datetimeFigureOut">
              <a:rPr kumimoji="1" lang="ja-JP" altLang="en-US" smtClean="0"/>
              <a:t>2023/8/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2C5E0B1-BE6D-8A00-2AF7-987512365F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51515AF-67EE-4548-107A-FFACAD13B0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C8AF9D-C38D-7B46-AAEB-D270530722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69609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7A71841-0CEB-8542-82FE-AE75D1DFFE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CA91115-61AB-7C70-3D0F-B4E7FAB879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9A9697AC-3C70-BE70-7D4F-E43D9C469A2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AD192108-619E-A549-7323-39A45FAB814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BBD4C653-47A6-2555-DCB5-F72C321EAB6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DAE33336-0B0E-C229-8F8F-AAE624E715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79B21-1E7E-E942-8EE5-E28162366F82}" type="datetimeFigureOut">
              <a:rPr kumimoji="1" lang="ja-JP" altLang="en-US" smtClean="0"/>
              <a:t>2023/8/9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00DD360C-6020-64F9-DDE1-6E0F3C7D41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6DBF2247-E866-6D05-FA0C-7969DE1D5C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C8AF9D-C38D-7B46-AAEB-D270530722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14721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52E4F1E-5528-7BCA-6615-2520F1B839C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6914AD56-E302-4A00-0574-8402F4CD14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79B21-1E7E-E942-8EE5-E28162366F82}" type="datetimeFigureOut">
              <a:rPr kumimoji="1" lang="ja-JP" altLang="en-US" smtClean="0"/>
              <a:t>2023/8/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73560FB7-08A6-CB81-65BA-F420D47C68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71A9CB55-102F-C3DC-BC35-B2E82F40EC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C8AF9D-C38D-7B46-AAEB-D270530722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42799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93161A4E-6169-25C6-9397-7ECEAFC973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79B21-1E7E-E942-8EE5-E28162366F82}" type="datetimeFigureOut">
              <a:rPr kumimoji="1" lang="ja-JP" altLang="en-US" smtClean="0"/>
              <a:t>2023/8/9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0682B62E-21FD-AB70-98B6-C9151094E8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B9E01A3A-3BF0-AB7E-9FA6-F111DEFB45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C8AF9D-C38D-7B46-AAEB-D270530722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00747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F0FBD2E-E3D1-7101-7D54-41D320762D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0279E23-6262-ABDC-F232-B7516E43060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19FAA6D-AA35-46F4-EE1B-F7F484A409C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B65119A-8077-1151-E460-19CEE932CF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79B21-1E7E-E942-8EE5-E28162366F82}" type="datetimeFigureOut">
              <a:rPr kumimoji="1" lang="ja-JP" altLang="en-US" smtClean="0"/>
              <a:t>2023/8/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0E08203-CCFC-06DD-4E5C-799EA4B5A1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770AC68-B5D3-2763-BE04-DC657B4740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C8AF9D-C38D-7B46-AAEB-D270530722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18816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F0CF789-7395-A9D8-F4AF-03B6728495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6FBC56CC-A0F0-3A03-7320-3668F114C46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38E1C68-47D1-4729-0344-978C80B195F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FD6991B-6BED-7246-5166-79998A629D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379B21-1E7E-E942-8EE5-E28162366F82}" type="datetimeFigureOut">
              <a:rPr kumimoji="1" lang="ja-JP" altLang="en-US" smtClean="0"/>
              <a:t>2023/8/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BF0AA48-A5A4-08B7-D5CF-73C09D4A19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023EA40-9CB2-4693-60D6-F2EC01DBE8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C8AF9D-C38D-7B46-AAEB-D270530722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94193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DE6BB3C7-67B5-6DEE-34F8-6235BA18FFC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CFBA5DE-B37B-A2E4-E399-FEA813BB4F5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E861685-0AC9-CB21-92AB-8D6D3D119CD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379B21-1E7E-E942-8EE5-E28162366F82}" type="datetimeFigureOut">
              <a:rPr kumimoji="1" lang="ja-JP" altLang="en-US" smtClean="0"/>
              <a:t>2023/8/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B196528-9A60-3E7C-D6D3-01F6D642BD4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8504B6B-23B3-EA0A-5025-3883ED688BA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C8AF9D-C38D-7B46-AAEB-D270530722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265680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Group 114">
            <a:extLst>
              <a:ext uri="{FF2B5EF4-FFF2-40B4-BE49-F238E27FC236}">
                <a16:creationId xmlns:a16="http://schemas.microsoft.com/office/drawing/2014/main" id="{86AA032A-11C4-2799-DE1B-E8D17468E30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22028268"/>
              </p:ext>
            </p:extLst>
          </p:nvPr>
        </p:nvGraphicFramePr>
        <p:xfrm>
          <a:off x="758011" y="831414"/>
          <a:ext cx="10729912" cy="3864864"/>
        </p:xfrm>
        <a:graphic>
          <a:graphicData uri="http://schemas.openxmlformats.org/drawingml/2006/table">
            <a:tbl>
              <a:tblPr/>
              <a:tblGrid>
                <a:gridCol w="3560555">
                  <a:extLst>
                    <a:ext uri="{9D8B030D-6E8A-4147-A177-3AD203B41FA5}">
                      <a16:colId xmlns:a16="http://schemas.microsoft.com/office/drawing/2014/main" val="1832121151"/>
                    </a:ext>
                  </a:extLst>
                </a:gridCol>
                <a:gridCol w="2362639">
                  <a:extLst>
                    <a:ext uri="{9D8B030D-6E8A-4147-A177-3AD203B41FA5}">
                      <a16:colId xmlns:a16="http://schemas.microsoft.com/office/drawing/2014/main" val="2918329094"/>
                    </a:ext>
                  </a:extLst>
                </a:gridCol>
                <a:gridCol w="1375026">
                  <a:extLst>
                    <a:ext uri="{9D8B030D-6E8A-4147-A177-3AD203B41FA5}">
                      <a16:colId xmlns:a16="http://schemas.microsoft.com/office/drawing/2014/main" val="3616635017"/>
                    </a:ext>
                  </a:extLst>
                </a:gridCol>
                <a:gridCol w="2315216">
                  <a:extLst>
                    <a:ext uri="{9D8B030D-6E8A-4147-A177-3AD203B41FA5}">
                      <a16:colId xmlns:a16="http://schemas.microsoft.com/office/drawing/2014/main" val="3066246409"/>
                    </a:ext>
                  </a:extLst>
                </a:gridCol>
                <a:gridCol w="1116476">
                  <a:extLst>
                    <a:ext uri="{9D8B030D-6E8A-4147-A177-3AD203B41FA5}">
                      <a16:colId xmlns:a16="http://schemas.microsoft.com/office/drawing/2014/main" val="1929097079"/>
                    </a:ext>
                  </a:extLst>
                </a:gridCol>
              </a:tblGrid>
              <a:tr h="278339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ts val="26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1" lang="ja-JP" altLang="en-US" sz="1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 horzOverflow="overflow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gridSpan="2"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ts val="26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6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univariate analysis</a:t>
                      </a:r>
                      <a:endParaRPr kumimoji="1" lang="ja-JP" altLang="ja-JP" sz="1600" b="1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 horzOverflow="overflow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2"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ts val="26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6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ＭＳ 明朝" panose="02020609040205080304" pitchFamily="49" charset="-128"/>
                          <a:cs typeface="Times New Roman" panose="02020603050405020304" pitchFamily="18" charset="0"/>
                        </a:rPr>
                        <a:t>mutivariate analysis</a:t>
                      </a:r>
                      <a:endParaRPr kumimoji="1" lang="ja-JP" altLang="ja-JP" sz="1600" b="1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 horzOverflow="overflow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9495951"/>
                  </a:ext>
                </a:extLst>
              </a:tr>
              <a:tr h="278339"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ts val="26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6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Variable</a:t>
                      </a:r>
                      <a:endParaRPr kumimoji="1" lang="ja-JP" altLang="ja-JP" sz="1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 horzOverflow="overflow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ts val="26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6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HR (95%CI)</a:t>
                      </a:r>
                      <a:endParaRPr kumimoji="1" lang="ja-JP" altLang="ja-JP" sz="1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 horzOverflow="overflow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ts val="26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600" b="1" i="1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kumimoji="1" lang="en-US" altLang="ja-JP" sz="16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 value </a:t>
                      </a:r>
                      <a:endParaRPr kumimoji="1" lang="ja-JP" altLang="ja-JP" sz="1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 horzOverflow="overflow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ts val="26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600" b="1" i="0" u="none" strike="noStrike" cap="none" normalizeH="0" baseline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HR (95%CI)</a:t>
                      </a:r>
                      <a:endParaRPr kumimoji="1" lang="ja-JP" altLang="ja-JP" sz="1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 horzOverflow="overflow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>
                      <a:lvl1pPr>
                        <a:spcBef>
                          <a:spcPct val="20000"/>
                        </a:spcBef>
                        <a:defRPr kumimoji="1" sz="2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1pPr>
                      <a:lvl2pPr marL="742950" indent="-285750">
                        <a:spcBef>
                          <a:spcPct val="20000"/>
                        </a:spcBef>
                        <a:defRPr kumimoji="1" sz="24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2pPr>
                      <a:lvl3pPr marL="1143000" indent="-228600">
                        <a:spcBef>
                          <a:spcPct val="20000"/>
                        </a:spcBef>
                        <a:defRPr kumimoji="1" sz="20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3pPr>
                      <a:lvl4pPr marL="16002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4pPr>
                      <a:lvl5pPr marL="2057400" indent="-228600">
                        <a:spcBef>
                          <a:spcPct val="20000"/>
                        </a:spcBef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5pPr>
                      <a:lvl6pPr marL="25146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6pPr>
                      <a:lvl7pPr marL="29718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7pPr>
                      <a:lvl8pPr marL="34290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8pPr>
                      <a:lvl9pPr marL="3886200" indent="-228600" fontAlgn="base">
                        <a:spcBef>
                          <a:spcPct val="20000"/>
                        </a:spcBef>
                        <a:spcAft>
                          <a:spcPct val="0"/>
                        </a:spcAft>
                        <a:defRPr kumimoji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ＭＳ Ｐゴシック" panose="020B0600070205080204" pitchFamily="34" charset="-128"/>
                        </a:defRPr>
                      </a:lvl9pPr>
                    </a:lstStyle>
                    <a:p>
                      <a:pPr marL="0" marR="0" lvl="0" indent="0" algn="ctr" defTabSz="914400" rtl="0" eaLnBrk="1" fontAlgn="base" latinLnBrk="0" hangingPunct="1">
                        <a:lnSpc>
                          <a:spcPts val="26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r>
                        <a:rPr kumimoji="1" lang="en-US" altLang="ja-JP" sz="1600" b="1" i="1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p </a:t>
                      </a:r>
                      <a:r>
                        <a:rPr kumimoji="1" lang="en-US" altLang="ja-JP" sz="1600" b="1" i="0" u="none" strike="noStrike" cap="none" normalizeH="0" baseline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value </a:t>
                      </a:r>
                      <a:endParaRPr kumimoji="1" lang="ja-JP" altLang="ja-JP" sz="1600" b="0" i="0" u="none" strike="noStrike" cap="none" normalizeH="0" baseline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ＭＳ 明朝" panose="02020609040205080304" pitchFamily="49" charset="-128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b" horzOverflow="overflow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44885774"/>
                  </a:ext>
                </a:extLst>
              </a:tr>
              <a:tr h="316050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Age (year)</a:t>
                      </a:r>
                      <a:endParaRPr kumimoji="1" lang="ja-JP" altLang="en-US" sz="160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.014 (0.991–1.039)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237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s-IS" sz="1600" b="0" i="0" u="none" strike="noStrike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b-NO" sz="1600" b="0" i="0" u="none" strike="noStrike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28727498"/>
                  </a:ext>
                </a:extLst>
              </a:tr>
              <a:tr h="316050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Sex (male vs. female)</a:t>
                      </a:r>
                      <a:endParaRPr kumimoji="1" lang="ja-JP" altLang="en-US" sz="160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.047 (0.534–2.054)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893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s-IS" sz="1600" b="0" i="0" u="none" strike="noStrike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b-NO" sz="1600" b="0" i="0" u="none" strike="noStrike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84188530"/>
                  </a:ext>
                </a:extLst>
              </a:tr>
              <a:tr h="426905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Presence of pre-treatment </a:t>
                      </a: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yes vs. no)</a:t>
                      </a:r>
                      <a:endParaRPr kumimoji="1" lang="ja-JP" altLang="en-US" sz="160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.578 (0.679–3.666)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289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s-IS" sz="1600" b="0" i="0" u="none" strike="noStrike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b-NO" sz="1600" b="0" i="0" u="none" strike="noStrike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72243548"/>
                  </a:ext>
                </a:extLst>
              </a:tr>
              <a:tr h="316050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AFP (10</a:t>
                      </a:r>
                      <a:r>
                        <a:rPr kumimoji="1" lang="en-US" altLang="ja-JP" sz="1600" baseline="30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 × ng/mL)</a:t>
                      </a:r>
                      <a:endParaRPr kumimoji="1" lang="ja-JP" altLang="en-US" sz="160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600" b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.002 (1.001–1.003)</a:t>
                      </a:r>
                      <a:endParaRPr lang="is-IS" sz="1600" b="0" i="0" u="none" strike="noStrike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 0.003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600" b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.002 (1.001–1.003)</a:t>
                      </a:r>
                      <a:endParaRPr lang="is-IS" sz="1600" b="0" i="0" u="none" strike="noStrike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07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93935703"/>
                  </a:ext>
                </a:extLst>
              </a:tr>
              <a:tr h="31605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PIVKA-II (10</a:t>
                      </a:r>
                      <a:r>
                        <a:rPr kumimoji="1" lang="en-US" altLang="ja-JP" sz="1600" baseline="30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 × </a:t>
                      </a:r>
                      <a:r>
                        <a:rPr kumimoji="1" lang="en-US" altLang="ja-JP" sz="1600" dirty="0" err="1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mAU</a:t>
                      </a:r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/mL)</a:t>
                      </a:r>
                      <a:endParaRPr kumimoji="1" lang="ja-JP" altLang="en-US" sz="160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600" b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.006 (1.003–1.009)</a:t>
                      </a:r>
                      <a:endParaRPr lang="is-IS" sz="1600" b="0" i="0" u="none" strike="noStrike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&lt; 0.001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600" b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.004 (1.001–1.008)</a:t>
                      </a:r>
                      <a:endParaRPr lang="is-IS" sz="1600" b="0" i="0" u="none" strike="noStrike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12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48607502"/>
                  </a:ext>
                </a:extLst>
              </a:tr>
              <a:tr h="31605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ALBI score</a:t>
                      </a:r>
                      <a:endParaRPr kumimoji="1" lang="ja-JP" altLang="en-US" sz="160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.789 (1.272–2.516)</a:t>
                      </a:r>
                      <a:endParaRPr lang="mr-IN" sz="1600" b="0" i="0" u="none" strike="noStrike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cs typeface="Times New Roman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600" b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&lt; 0.001</a:t>
                      </a:r>
                      <a:endParaRPr lang="nb-NO" sz="1600" b="0" i="0" u="none" strike="noStrike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600" b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.676 (1.145–2.452)</a:t>
                      </a:r>
                      <a:endParaRPr lang="is-IS" sz="1600" b="0" i="0" u="none" strike="noStrike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08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82759399"/>
                  </a:ext>
                </a:extLst>
              </a:tr>
              <a:tr h="31605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SMI (cm</a:t>
                      </a:r>
                      <a:r>
                        <a:rPr kumimoji="1" lang="en-US" altLang="ja-JP" sz="1600" baseline="30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/m</a:t>
                      </a:r>
                      <a:r>
                        <a:rPr kumimoji="1" lang="en-US" altLang="ja-JP" sz="1600" baseline="30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kumimoji="1" lang="ja-JP" altLang="en-US" sz="160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954 (0.924–0.985)</a:t>
                      </a:r>
                      <a:endParaRPr lang="mr-IN" sz="1600" b="0" i="0" u="none" strike="noStrike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cs typeface="Times New Roman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004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s-IS" sz="1600" b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975 (0.944–1.006)</a:t>
                      </a:r>
                      <a:endParaRPr lang="is-IS" sz="1600" b="0" i="0" u="none" strike="noStrike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118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57697164"/>
                  </a:ext>
                </a:extLst>
              </a:tr>
              <a:tr h="31605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SATI (cm</a:t>
                      </a:r>
                      <a:r>
                        <a:rPr kumimoji="1" lang="en-US" altLang="ja-JP" sz="1600" baseline="30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/m</a:t>
                      </a:r>
                      <a:r>
                        <a:rPr kumimoji="1" lang="en-US" altLang="ja-JP" sz="1600" baseline="30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kumimoji="1" lang="ja-JP" altLang="en-US" sz="160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995 (0.984–1.005)</a:t>
                      </a:r>
                      <a:endParaRPr lang="mr-IN" sz="1600" b="0" i="0" u="none" strike="noStrike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cs typeface="Times New Roman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600" b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318</a:t>
                      </a:r>
                      <a:endParaRPr lang="nb-NO" sz="1600" b="0" i="0" u="none" strike="noStrike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s-IS" sz="1600" b="0" i="0" u="none" strike="noStrike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b-NO" sz="1600" b="0" i="0" u="none" strike="noStrike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90710444"/>
                  </a:ext>
                </a:extLst>
              </a:tr>
              <a:tr h="31605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VATI (cm</a:t>
                      </a:r>
                      <a:r>
                        <a:rPr kumimoji="1" lang="en-US" altLang="ja-JP" sz="1600" baseline="30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/m</a:t>
                      </a:r>
                      <a:r>
                        <a:rPr kumimoji="1" lang="en-US" altLang="ja-JP" sz="1600" baseline="300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kumimoji="1" lang="ja-JP" altLang="en-US" sz="160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600" b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993 (0.981–1.005)</a:t>
                      </a:r>
                      <a:endParaRPr lang="mr-IN" sz="1600" b="0" i="0" u="none" strike="noStrike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cs typeface="Times New Roman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nb-NO" sz="16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229</a:t>
                      </a:r>
                    </a:p>
                  </a:txBody>
                  <a:tcPr marL="45720" marR="4572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is-IS" sz="1600" b="0" i="0" u="none" strike="noStrike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nb-NO" sz="1600" b="0" i="0" u="none" strike="noStrike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5720" marR="45720" anchor="ctr">
                    <a:lnL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FFFFFF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86511211"/>
                  </a:ext>
                </a:extLst>
              </a:tr>
            </a:tbl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E70DD869-0B6B-DCC9-F7B8-7A0187D73FC8}"/>
              </a:ext>
            </a:extLst>
          </p:cNvPr>
          <p:cNvSpPr txBox="1"/>
          <p:nvPr/>
        </p:nvSpPr>
        <p:spPr>
          <a:xfrm>
            <a:off x="460335" y="190658"/>
            <a:ext cx="1132526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Table </a:t>
            </a:r>
            <a:r>
              <a:rPr lang="en-US" altLang="ja-JP" sz="16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S1</a:t>
            </a:r>
            <a:r>
              <a:rPr kumimoji="1" lang="en-US" altLang="ja-JP" sz="16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. </a:t>
            </a:r>
            <a:r>
              <a:rPr kumimoji="0" lang="en-US" altLang="ja-JP" sz="16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Palatino Linotype" panose="02040502050505030304" pitchFamily="18" charset="0"/>
                <a:ea typeface="ＭＳ Ｐゴシック" charset="0"/>
              </a:rPr>
              <a:t>Analysis of factors that would affect PFS</a:t>
            </a:r>
            <a:r>
              <a:rPr lang="en-US" altLang="ja-JP" sz="160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 </a:t>
            </a:r>
            <a:r>
              <a:rPr lang="en-US" altLang="ja-JP" sz="1600" dirty="0"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Cordia New" panose="020B0304020202020204" pitchFamily="34" charset="-34"/>
              </a:rPr>
              <a:t>using time-varying covariates in the Cox model.</a:t>
            </a:r>
            <a:endParaRPr lang="ja-JP" altLang="ja-JP" sz="1600">
              <a:effectLst/>
              <a:latin typeface="Palatino Linotype" panose="02040502050505030304" pitchFamily="18" charset="0"/>
              <a:ea typeface="Times New Roman" panose="02020603050405020304" pitchFamily="18" charset="0"/>
              <a:cs typeface="Cordia New" panose="020B0304020202020204" pitchFamily="34" charset="-34"/>
            </a:endParaRPr>
          </a:p>
          <a:p>
            <a:endParaRPr kumimoji="0" lang="en-US" altLang="ja-JP" sz="16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Palatino Linotype" panose="02040502050505030304" pitchFamily="18" charset="0"/>
              <a:ea typeface="ＭＳ Ｐゴシック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15738662-B486-DCEE-D080-281E774150FE}"/>
              </a:ext>
            </a:extLst>
          </p:cNvPr>
          <p:cNvSpPr txBox="1"/>
          <p:nvPr/>
        </p:nvSpPr>
        <p:spPr>
          <a:xfrm>
            <a:off x="758010" y="4699078"/>
            <a:ext cx="1072991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FS, progression free survival; HR, hazard ratio; CI, </a:t>
            </a:r>
            <a:r>
              <a:rPr lang="en-US" altLang="ja-JP" sz="1600" kern="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</a:rPr>
              <a:t>confidence interval;</a:t>
            </a:r>
            <a:r>
              <a:rPr lang="ja-JP" altLang="ja-JP" sz="1600">
                <a:effectLst/>
                <a:latin typeface="Palatino Linotype" panose="02040502050505030304" pitchFamily="18" charset="0"/>
              </a:rPr>
              <a:t> </a:t>
            </a:r>
            <a:r>
              <a:rPr lang="en-US" altLang="ja-JP" sz="1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MI, skeletal muscle index; SATI, subcutaneous adipose tissue index; VATI, visceral adipose tissue index</a:t>
            </a:r>
            <a:endParaRPr kumimoji="1" lang="ja-JP" altLang="en-US" sz="160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638047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9FF550F-C155-2BA1-6018-4C015E21B428}"/>
              </a:ext>
            </a:extLst>
          </p:cNvPr>
          <p:cNvSpPr txBox="1"/>
          <p:nvPr/>
        </p:nvSpPr>
        <p:spPr>
          <a:xfrm>
            <a:off x="120316" y="190658"/>
            <a:ext cx="119353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Table S2</a:t>
            </a:r>
            <a:r>
              <a:rPr lang="en-US" altLang="ja-JP" sz="16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. The differences in</a:t>
            </a:r>
            <a:r>
              <a:rPr kumimoji="0" lang="en-US" altLang="ja-JP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Palatino Linotype" panose="02040502050505030304" pitchFamily="18" charset="0"/>
                <a:ea typeface="游ゴシック" panose="020B0400000000000000" pitchFamily="34" charset="-128"/>
                <a:cs typeface="Times New Roman" panose="02020603050405020304" pitchFamily="18" charset="0"/>
              </a:rPr>
              <a:t> clinical characteristics and adverse events between the SMI rapid depletion and non-depletion groups</a:t>
            </a:r>
            <a:endParaRPr kumimoji="0" lang="ja-JP" altLang="en-US" sz="1600">
              <a:solidFill>
                <a:prstClr val="black"/>
              </a:solidFill>
              <a:latin typeface="Palatino Linotype" panose="02040502050505030304" pitchFamily="18" charset="0"/>
              <a:ea typeface="游ゴシック" panose="020B0400000000000000" pitchFamily="34" charset="-128"/>
              <a:cs typeface="Times New Roman" panose="02020603050405020304" pitchFamily="18" charset="0"/>
            </a:endParaRPr>
          </a:p>
        </p:txBody>
      </p:sp>
      <p:graphicFrame>
        <p:nvGraphicFramePr>
          <p:cNvPr id="4" name="表 4">
            <a:extLst>
              <a:ext uri="{FF2B5EF4-FFF2-40B4-BE49-F238E27FC236}">
                <a16:creationId xmlns:a16="http://schemas.microsoft.com/office/drawing/2014/main" id="{63793370-A0B2-473F-8FD8-E315690949F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87655833"/>
              </p:ext>
            </p:extLst>
          </p:nvPr>
        </p:nvGraphicFramePr>
        <p:xfrm>
          <a:off x="786426" y="824312"/>
          <a:ext cx="10673082" cy="4737728"/>
        </p:xfrm>
        <a:graphic>
          <a:graphicData uri="http://schemas.openxmlformats.org/drawingml/2006/table">
            <a:tbl>
              <a:tblPr>
                <a:tableStyleId>{7E9639D4-E3E2-4D34-9284-5A2195B3D0D7}</a:tableStyleId>
              </a:tblPr>
              <a:tblGrid>
                <a:gridCol w="3714137">
                  <a:extLst>
                    <a:ext uri="{9D8B030D-6E8A-4147-A177-3AD203B41FA5}">
                      <a16:colId xmlns:a16="http://schemas.microsoft.com/office/drawing/2014/main" val="549723763"/>
                    </a:ext>
                  </a:extLst>
                </a:gridCol>
                <a:gridCol w="2657475">
                  <a:extLst>
                    <a:ext uri="{9D8B030D-6E8A-4147-A177-3AD203B41FA5}">
                      <a16:colId xmlns:a16="http://schemas.microsoft.com/office/drawing/2014/main" val="1087648654"/>
                    </a:ext>
                  </a:extLst>
                </a:gridCol>
                <a:gridCol w="3271837">
                  <a:extLst>
                    <a:ext uri="{9D8B030D-6E8A-4147-A177-3AD203B41FA5}">
                      <a16:colId xmlns:a16="http://schemas.microsoft.com/office/drawing/2014/main" val="3726580142"/>
                    </a:ext>
                  </a:extLst>
                </a:gridCol>
                <a:gridCol w="1029633">
                  <a:extLst>
                    <a:ext uri="{9D8B030D-6E8A-4147-A177-3AD203B41FA5}">
                      <a16:colId xmlns:a16="http://schemas.microsoft.com/office/drawing/2014/main" val="1726986217"/>
                    </a:ext>
                  </a:extLst>
                </a:gridCol>
              </a:tblGrid>
              <a:tr h="435324">
                <a:tc>
                  <a:txBody>
                    <a:bodyPr/>
                    <a:lstStyle/>
                    <a:p>
                      <a:pPr algn="ctr"/>
                      <a:endParaRPr kumimoji="1" lang="ja-JP" altLang="en-US" sz="1600" b="0" i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153" marR="77153" marT="38576" marB="38576">
                    <a:lnL w="6350" cap="flat" cmpd="sng" algn="ctr">
                      <a:noFill/>
                      <a:prstDash val="solid"/>
                      <a:miter lim="800000"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rapid SMI depletion group (n = 19)</a:t>
                      </a:r>
                      <a:endParaRPr kumimoji="1" lang="ja-JP" altLang="en-US" sz="1600" b="0" i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153" marR="77153" marT="38576" marB="38576">
                    <a:lnL>
                      <a:noFill/>
                    </a:lnL>
                    <a:lnR>
                      <a:noFill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non-rapid SMI depletion group </a:t>
                      </a:r>
                    </a:p>
                    <a:p>
                      <a:pPr algn="ctr"/>
                      <a:r>
                        <a:rPr kumimoji="1" lang="en-US" altLang="ja-JP" sz="16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(n = 58)</a:t>
                      </a:r>
                      <a:endParaRPr kumimoji="1" lang="ja-JP" altLang="en-US" sz="1600" b="0" i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153" marR="77153" marT="38576" marB="38576">
                    <a:lnL>
                      <a:noFill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i="1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r>
                        <a:rPr kumimoji="1" lang="en-US" altLang="ja-JP" sz="16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 value</a:t>
                      </a:r>
                      <a:endParaRPr kumimoji="1" lang="ja-JP" altLang="en-US" sz="1600" b="0" i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153" marR="77153" marT="38576" marB="38576">
                    <a:lnL>
                      <a:noFill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143307108"/>
                  </a:ext>
                </a:extLst>
              </a:tr>
              <a:tr h="247393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Median survival (months)</a:t>
                      </a:r>
                      <a:endParaRPr kumimoji="1" lang="ja-JP" altLang="en-US" sz="1600" b="0" i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153" marR="77153" marT="38576" marB="38576">
                    <a:lnL w="6350" cap="flat" cmpd="sng" algn="ctr">
                      <a:noFill/>
                      <a:prstDash val="solid"/>
                      <a:miter lim="800000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5.7 (10.9–22.8)</a:t>
                      </a:r>
                      <a:endParaRPr kumimoji="1" lang="ja-JP" altLang="en-US" sz="1600" b="0" i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153" marR="77153" marT="38576" marB="38576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3.1 (13.1–35.1)</a:t>
                      </a:r>
                      <a:endParaRPr kumimoji="1" lang="ja-JP" altLang="en-US" sz="1600" b="0" i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153" marR="77153" marT="38576" marB="38576">
                    <a:lnL>
                      <a:noFill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&lt;0.001</a:t>
                      </a:r>
                      <a:endParaRPr kumimoji="1" lang="ja-JP" altLang="en-US" sz="1600" b="0" i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153" marR="77153" marT="38576" marB="38576">
                    <a:lnL>
                      <a:noFill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72604887"/>
                  </a:ext>
                </a:extLst>
              </a:tr>
              <a:tr h="247393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6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Age</a:t>
                      </a:r>
                    </a:p>
                  </a:txBody>
                  <a:tcPr marL="77153" marR="77153" marT="38576" marB="38576">
                    <a:lnL w="6350" cap="flat" cmpd="sng" algn="ctr">
                      <a:noFill/>
                      <a:prstDash val="solid"/>
                      <a:miter lim="800000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76 (61.5–78.5)</a:t>
                      </a:r>
                      <a:endParaRPr kumimoji="1" lang="ja-JP" altLang="en-US" sz="1600" b="0" i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153" marR="77153" marT="38576" marB="3857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73 (66–78)</a:t>
                      </a:r>
                      <a:endParaRPr kumimoji="1" lang="ja-JP" altLang="en-US" sz="1600" b="0" i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153" marR="77153" marT="38576" marB="38576">
                    <a:lnL>
                      <a:noFill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586</a:t>
                      </a:r>
                      <a:endParaRPr kumimoji="1" lang="ja-JP" altLang="en-US" sz="1600" b="0" i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153" marR="77153" marT="38576" marB="38576">
                    <a:lnL>
                      <a:noFill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128196151"/>
                  </a:ext>
                </a:extLst>
              </a:tr>
              <a:tr h="247393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Sex (male/female)</a:t>
                      </a:r>
                    </a:p>
                  </a:txBody>
                  <a:tcPr marL="77153" marR="77153" marT="38576" marB="38576">
                    <a:lnL w="6350" cap="flat" cmpd="sng" algn="ctr">
                      <a:noFill/>
                      <a:prstDash val="solid"/>
                      <a:miter lim="800000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8/1</a:t>
                      </a:r>
                      <a:endParaRPr kumimoji="1" lang="ja-JP" altLang="en-US" sz="1600" b="0" i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153" marR="77153" marT="38576" marB="3857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48/18</a:t>
                      </a:r>
                      <a:endParaRPr kumimoji="1" lang="ja-JP" altLang="en-US" sz="1600" b="0" i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153" marR="77153" marT="38576" marB="38576">
                    <a:lnL>
                      <a:noFill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275</a:t>
                      </a:r>
                      <a:endParaRPr kumimoji="1" lang="ja-JP" altLang="en-US" sz="1600" b="0" i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153" marR="77153" marT="38576" marB="38576">
                    <a:lnL>
                      <a:noFill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487445643"/>
                  </a:ext>
                </a:extLst>
              </a:tr>
              <a:tr h="247393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Best response (CR/PR/SD/PD) </a:t>
                      </a:r>
                      <a:endParaRPr kumimoji="1" lang="ja-JP" altLang="en-US" sz="1600" b="0" i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153" marR="77153" marT="38576" marB="38576">
                    <a:lnL w="6350" cap="flat" cmpd="sng" algn="ctr">
                      <a:noFill/>
                      <a:prstDash val="solid"/>
                      <a:miter lim="800000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/5/7/7</a:t>
                      </a:r>
                      <a:endParaRPr kumimoji="1" lang="ja-JP" altLang="en-US" sz="1600" b="0" i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153" marR="77153" marT="38576" marB="3857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7/10/13/28</a:t>
                      </a:r>
                      <a:endParaRPr kumimoji="1" lang="ja-JP" altLang="en-US" sz="1600" b="0" i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153" marR="77153" marT="38576" marB="38576">
                    <a:lnL>
                      <a:noFill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239</a:t>
                      </a:r>
                      <a:endParaRPr kumimoji="1" lang="ja-JP" altLang="en-US" sz="1600" b="0" i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153" marR="77153" marT="38576" marB="38576">
                    <a:lnL>
                      <a:noFill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355217409"/>
                  </a:ext>
                </a:extLst>
              </a:tr>
              <a:tr h="247393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Drug (</a:t>
                      </a:r>
                      <a:r>
                        <a:rPr kumimoji="1" lang="en-US" altLang="ja-JP" sz="1600" b="0" i="0" dirty="0" err="1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lenvatinib</a:t>
                      </a:r>
                      <a:r>
                        <a:rPr kumimoji="1" lang="en-US" altLang="ja-JP" sz="16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/sorafenib)</a:t>
                      </a:r>
                      <a:endParaRPr kumimoji="1" lang="ja-JP" altLang="en-US" sz="1600" b="0" i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153" marR="77153" marT="38576" marB="38576">
                    <a:lnL w="6350" cap="flat" cmpd="sng" algn="ctr">
                      <a:noFill/>
                      <a:prstDash val="solid"/>
                      <a:miter lim="800000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8/11</a:t>
                      </a:r>
                      <a:endParaRPr kumimoji="1" lang="ja-JP" altLang="en-US" sz="1600" b="0" i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153" marR="77153" marT="38576" marB="3857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0/38</a:t>
                      </a:r>
                      <a:endParaRPr kumimoji="1" lang="ja-JP" altLang="en-US" sz="1600" b="0" i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153" marR="77153" marT="38576" marB="38576">
                    <a:lnL>
                      <a:noFill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590</a:t>
                      </a:r>
                      <a:endParaRPr kumimoji="1" lang="ja-JP" altLang="en-US" sz="1600" b="0" i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153" marR="77153" marT="38576" marB="38576">
                    <a:lnL>
                      <a:noFill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69772894"/>
                  </a:ext>
                </a:extLst>
              </a:tr>
              <a:tr h="247393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Combination treatment (yes/no)</a:t>
                      </a:r>
                      <a:endParaRPr kumimoji="1" lang="ja-JP" altLang="en-US" sz="1600" b="0" i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153" marR="77153" marT="38576" marB="38576">
                    <a:lnL w="6350" cap="flat" cmpd="sng" algn="ctr">
                      <a:noFill/>
                      <a:prstDash val="solid"/>
                      <a:miter lim="800000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3/6</a:t>
                      </a:r>
                      <a:endParaRPr kumimoji="1" lang="ja-JP" altLang="en-US" sz="1600" b="0" i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153" marR="77153" marT="38576" marB="3857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36/22</a:t>
                      </a:r>
                      <a:endParaRPr kumimoji="1" lang="ja-JP" altLang="en-US" sz="1600" b="0" i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153" marR="77153" marT="38576" marB="38576">
                    <a:lnL>
                      <a:noFill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785</a:t>
                      </a:r>
                      <a:endParaRPr kumimoji="1" lang="ja-JP" altLang="en-US" sz="1600" b="0" i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153" marR="77153" marT="38576" marB="38576">
                    <a:lnL>
                      <a:noFill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19684946"/>
                  </a:ext>
                </a:extLst>
              </a:tr>
              <a:tr h="247393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Child Pugh score (5/6/7/8/9)</a:t>
                      </a:r>
                      <a:endParaRPr kumimoji="1" lang="ja-JP" altLang="en-US" sz="1600" b="0" i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153" marR="77153" marT="38576" marB="38576">
                    <a:lnL w="6350" cap="flat" cmpd="sng" algn="ctr">
                      <a:noFill/>
                      <a:prstDash val="solid"/>
                      <a:miter lim="800000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4/5/0/0/0</a:t>
                      </a:r>
                      <a:endParaRPr kumimoji="1" lang="ja-JP" altLang="en-US" sz="1600" b="0" i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153" marR="77153" marT="38576" marB="3857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45/11/1/0/1</a:t>
                      </a:r>
                      <a:endParaRPr kumimoji="1" lang="ja-JP" altLang="en-US" sz="1600" b="0" i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153" marR="77153" marT="38576" marB="38576">
                    <a:lnL>
                      <a:noFill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736</a:t>
                      </a:r>
                      <a:endParaRPr kumimoji="1" lang="ja-JP" altLang="en-US" sz="1600" b="0" i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153" marR="77153" marT="38576" marB="38576">
                    <a:lnL>
                      <a:noFill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513404123"/>
                  </a:ext>
                </a:extLst>
              </a:tr>
              <a:tr h="247393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ALBI score</a:t>
                      </a:r>
                      <a:endParaRPr kumimoji="1" lang="ja-JP" altLang="en-US" sz="1600" b="0" i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153" marR="77153" marT="38576" marB="38576">
                    <a:lnL w="6350" cap="flat" cmpd="sng" algn="ctr">
                      <a:noFill/>
                      <a:prstDash val="solid"/>
                      <a:miter lim="800000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-2.47 (-2.92– -2.22)</a:t>
                      </a:r>
                      <a:endParaRPr kumimoji="1" lang="ja-JP" altLang="en-US" sz="1600" b="0" i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153" marR="77153" marT="38576" marB="3857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-2.63 (-2.89– -2.28)</a:t>
                      </a:r>
                      <a:endParaRPr kumimoji="1" lang="ja-JP" altLang="en-US" sz="1600" b="0" i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153" marR="77153" marT="38576" marB="38576">
                    <a:lnL>
                      <a:noFill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628</a:t>
                      </a:r>
                      <a:endParaRPr kumimoji="1" lang="ja-JP" altLang="en-US" sz="1600" b="0" i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153" marR="77153" marT="38576" marB="38576">
                    <a:lnL>
                      <a:noFill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902381495"/>
                  </a:ext>
                </a:extLst>
              </a:tr>
              <a:tr h="247393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60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BCLC stage (B1/B2/C)</a:t>
                      </a:r>
                      <a:endParaRPr kumimoji="1" lang="ja-JP" altLang="en-US" sz="160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153" marR="77153" marT="38576" marB="38576">
                    <a:lnL w="6350" cap="flat" cmpd="sng" algn="ctr">
                      <a:noFill/>
                      <a:prstDash val="solid"/>
                      <a:miter lim="800000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3/3/13</a:t>
                      </a:r>
                      <a:endParaRPr kumimoji="1" lang="ja-JP" altLang="en-US" sz="1600" b="0" i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153" marR="77153" marT="38576" marB="3857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8/21/28</a:t>
                      </a:r>
                      <a:endParaRPr kumimoji="1" lang="ja-JP" altLang="en-US" sz="1600" b="0" i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153" marR="77153" marT="38576" marB="38576">
                    <a:lnL>
                      <a:noFill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231</a:t>
                      </a:r>
                      <a:endParaRPr kumimoji="1" lang="ja-JP" altLang="en-US" sz="1600" b="0" i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153" marR="77153" marT="38576" marB="38576">
                    <a:lnL>
                      <a:noFill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01382003"/>
                  </a:ext>
                </a:extLst>
              </a:tr>
              <a:tr h="247393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Appetite loss (Grade 0/1/2/≥3) </a:t>
                      </a:r>
                      <a:endParaRPr kumimoji="1" lang="ja-JP" altLang="en-US" sz="1600" b="0" i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153" marR="77153" marT="38576" marB="38576">
                    <a:lnL w="6350" cap="flat" cmpd="sng" algn="ctr">
                      <a:noFill/>
                      <a:prstDash val="solid"/>
                      <a:miter lim="800000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4/2/12/1</a:t>
                      </a:r>
                      <a:endParaRPr kumimoji="1" lang="ja-JP" altLang="en-US" sz="1600" b="0" i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153" marR="77153" marT="38576" marB="3857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8/5/24/1</a:t>
                      </a:r>
                      <a:endParaRPr kumimoji="1" lang="ja-JP" altLang="en-US" sz="1600" b="0" i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153" marR="77153" marT="38576" marB="38576">
                    <a:lnL>
                      <a:noFill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126</a:t>
                      </a:r>
                      <a:endParaRPr kumimoji="1" lang="ja-JP" altLang="en-US" sz="1600" b="0" i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153" marR="77153" marT="38576" marB="38576">
                    <a:lnL>
                      <a:noFill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102969477"/>
                  </a:ext>
                </a:extLst>
              </a:tr>
              <a:tr h="247393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Hand-foot syndrome (Grade 0/1/2/≥3) </a:t>
                      </a:r>
                      <a:endParaRPr kumimoji="1" lang="ja-JP" altLang="en-US" sz="1600" b="0" i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153" marR="77153" marT="38576" marB="38576">
                    <a:lnL w="6350" cap="flat" cmpd="sng" algn="ctr">
                      <a:noFill/>
                      <a:prstDash val="solid"/>
                      <a:miter lim="800000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2/3/4/0</a:t>
                      </a:r>
                      <a:endParaRPr kumimoji="1" lang="ja-JP" altLang="en-US" sz="1600" b="0" i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153" marR="77153" marT="38576" marB="3857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29/10/8/1</a:t>
                      </a:r>
                      <a:endParaRPr kumimoji="1" lang="ja-JP" altLang="en-US" sz="1600" b="0" i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153" marR="77153" marT="38576" marB="38576">
                    <a:lnL>
                      <a:noFill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758</a:t>
                      </a:r>
                      <a:endParaRPr kumimoji="1" lang="ja-JP" altLang="en-US" sz="1600" b="0" i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153" marR="77153" marT="38576" marB="38576">
                    <a:lnL>
                      <a:noFill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842679163"/>
                  </a:ext>
                </a:extLst>
              </a:tr>
              <a:tr h="247393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General fatigue (Grade 0/1/2/≥3) </a:t>
                      </a:r>
                      <a:endParaRPr kumimoji="1" lang="ja-JP" altLang="en-US" sz="1600" b="0" i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153" marR="77153" marT="38576" marB="38576">
                    <a:lnL w="6350" cap="flat" cmpd="sng" algn="ctr">
                      <a:noFill/>
                      <a:prstDash val="solid"/>
                      <a:miter lim="800000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8/2/9/0</a:t>
                      </a:r>
                      <a:endParaRPr kumimoji="1" lang="ja-JP" altLang="en-US" sz="1600" b="0" i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153" marR="77153" marT="38576" marB="3857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36/3/16/3</a:t>
                      </a:r>
                      <a:endParaRPr kumimoji="1" lang="ja-JP" altLang="en-US" sz="1600" b="0" i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153" marR="77153" marT="38576" marB="38576">
                    <a:lnL>
                      <a:noFill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210</a:t>
                      </a:r>
                      <a:endParaRPr kumimoji="1" lang="ja-JP" altLang="en-US" sz="1600" b="0" i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153" marR="77153" marT="38576" marB="38576">
                    <a:lnL>
                      <a:noFill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063656497"/>
                  </a:ext>
                </a:extLst>
              </a:tr>
              <a:tr h="247393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Diarrhea (Grade 0/1/2/≥3) </a:t>
                      </a:r>
                      <a:endParaRPr kumimoji="1" lang="ja-JP" altLang="en-US" sz="1600" b="0" i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153" marR="77153" marT="38576" marB="38576">
                    <a:lnL w="6350" cap="flat" cmpd="sng" algn="ctr">
                      <a:noFill/>
                      <a:prstDash val="solid"/>
                      <a:miter lim="800000"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14/4/1/0</a:t>
                      </a:r>
                      <a:endParaRPr kumimoji="1" lang="ja-JP" altLang="en-US" sz="1600" b="0" i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153" marR="77153" marT="38576" marB="3857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45/10/3/0</a:t>
                      </a:r>
                      <a:endParaRPr kumimoji="1" lang="ja-JP" altLang="en-US" sz="1600" b="0" i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153" marR="77153" marT="38576" marB="38576">
                    <a:lnL>
                      <a:noFill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600" b="0" i="0" dirty="0">
                          <a:solidFill>
                            <a:schemeClr val="tx1"/>
                          </a:solidFill>
                          <a:latin typeface="Palatino Linotype" panose="02040502050505030304" pitchFamily="18" charset="0"/>
                          <a:cs typeface="Times New Roman" panose="02020603050405020304" pitchFamily="18" charset="0"/>
                        </a:rPr>
                        <a:t>0.886</a:t>
                      </a:r>
                      <a:endParaRPr kumimoji="1" lang="ja-JP" altLang="en-US" sz="1600" b="0" i="0" dirty="0">
                        <a:solidFill>
                          <a:schemeClr val="tx1"/>
                        </a:solidFill>
                        <a:latin typeface="Palatino Linotype" panose="0204050205050503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77153" marR="77153" marT="38576" marB="38576">
                    <a:lnL>
                      <a:noFill/>
                    </a:lnL>
                    <a:lnR w="6350" cap="flat" cmpd="sng" algn="ctr">
                      <a:noFill/>
                      <a:prstDash val="solid"/>
                      <a:miter lim="800000"/>
                    </a:lnR>
                    <a:lnT>
                      <a:noFill/>
                    </a:lnT>
                    <a:lnB w="285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608304915"/>
                  </a:ext>
                </a:extLst>
              </a:tr>
            </a:tbl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DE33EB4B-CC6A-3C5C-649A-43596F27C662}"/>
              </a:ext>
            </a:extLst>
          </p:cNvPr>
          <p:cNvSpPr txBox="1"/>
          <p:nvPr/>
        </p:nvSpPr>
        <p:spPr>
          <a:xfrm>
            <a:off x="786426" y="5584152"/>
            <a:ext cx="1067308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ontinuous covariates are presented as median (interquartile range). SMI, skeletal muscle index; CR, complete response; PR, partial response; SD, stable disease; PD, progressive disease</a:t>
            </a:r>
            <a:r>
              <a:rPr lang="ja-JP" altLang="ja-JP" sz="1600">
                <a:effectLst/>
              </a:rPr>
              <a:t> </a:t>
            </a:r>
            <a:endParaRPr kumimoji="1" lang="ja-JP" altLang="en-US" sz="160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263242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8</TotalTime>
  <Words>426</Words>
  <Application>Microsoft Macintosh PowerPoint</Application>
  <PresentationFormat>ワイド画面</PresentationFormat>
  <Paragraphs>103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游ゴシック</vt:lpstr>
      <vt:lpstr>游ゴシック Light</vt:lpstr>
      <vt:lpstr>Arial</vt:lpstr>
      <vt:lpstr>Palatino Linotype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IMAI Kenji</dc:creator>
  <cp:lastModifiedBy>IMAI Kenji</cp:lastModifiedBy>
  <cp:revision>6</cp:revision>
  <dcterms:created xsi:type="dcterms:W3CDTF">2023-08-09T08:57:49Z</dcterms:created>
  <dcterms:modified xsi:type="dcterms:W3CDTF">2023-08-09T12:48:17Z</dcterms:modified>
</cp:coreProperties>
</file>